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943147" y="857232"/>
          <a:ext cx="6057876" cy="4773200"/>
        </p:xfrm>
        <a:graphic>
          <a:graphicData uri="http://schemas.openxmlformats.org/drawingml/2006/table">
            <a:tbl>
              <a:tblPr/>
              <a:tblGrid>
                <a:gridCol w="397289"/>
                <a:gridCol w="221742"/>
                <a:gridCol w="246381"/>
                <a:gridCol w="221742"/>
                <a:gridCol w="221742"/>
                <a:gridCol w="249460"/>
                <a:gridCol w="249460"/>
                <a:gridCol w="246381"/>
                <a:gridCol w="221742"/>
                <a:gridCol w="221742"/>
                <a:gridCol w="249460"/>
                <a:gridCol w="246381"/>
                <a:gridCol w="221742"/>
                <a:gridCol w="249460"/>
                <a:gridCol w="249460"/>
                <a:gridCol w="246381"/>
                <a:gridCol w="234061"/>
                <a:gridCol w="234061"/>
                <a:gridCol w="246381"/>
                <a:gridCol w="221742"/>
                <a:gridCol w="249460"/>
                <a:gridCol w="234061"/>
                <a:gridCol w="221742"/>
                <a:gridCol w="221742"/>
                <a:gridCol w="234061"/>
              </a:tblGrid>
              <a:tr h="187008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 rot="10800000">
            <a:off x="1446913" y="1391411"/>
            <a:ext cx="461665" cy="38949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Orange-spotted grouper linkage group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844740" y="490978"/>
            <a:ext cx="23926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Medaka chromosomes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PresentationFormat>全屏显示(4:3)</PresentationFormat>
  <Paragraphs>62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dell</cp:lastModifiedBy>
  <cp:revision>1</cp:revision>
  <dcterms:modified xsi:type="dcterms:W3CDTF">2013-06-21T14:37:01Z</dcterms:modified>
</cp:coreProperties>
</file>